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U$81:$U$98</c:f>
                <c:numCache>
                  <c:formatCode>General</c:formatCode>
                  <c:ptCount val="18"/>
                  <c:pt idx="0">
                    <c:v>7.7549889888936424E-6</c:v>
                  </c:pt>
                  <c:pt idx="1">
                    <c:v>5.1859630018413856E-3</c:v>
                  </c:pt>
                  <c:pt idx="2">
                    <c:v>3.123128555205015E-3</c:v>
                  </c:pt>
                  <c:pt idx="3">
                    <c:v>2.2719039082930305E-2</c:v>
                  </c:pt>
                  <c:pt idx="4">
                    <c:v>5.1695232113592319E-3</c:v>
                  </c:pt>
                  <c:pt idx="5">
                    <c:v>2.5647915638268913E-3</c:v>
                  </c:pt>
                  <c:pt idx="6">
                    <c:v>3.6907526535855446E-2</c:v>
                  </c:pt>
                  <c:pt idx="7">
                    <c:v>9.8989776765984697E-3</c:v>
                  </c:pt>
                  <c:pt idx="8">
                    <c:v>1.5276885137864786E-2</c:v>
                  </c:pt>
                  <c:pt idx="9">
                    <c:v>9.215947795092598E-3</c:v>
                  </c:pt>
                  <c:pt idx="10">
                    <c:v>2.2637674391669639E-3</c:v>
                  </c:pt>
                  <c:pt idx="11">
                    <c:v>3.2088469688136806E-2</c:v>
                  </c:pt>
                  <c:pt idx="12">
                    <c:v>1.2280013353630133E-2</c:v>
                  </c:pt>
                  <c:pt idx="13">
                    <c:v>7.1122783640403782E-3</c:v>
                  </c:pt>
                  <c:pt idx="14">
                    <c:v>2.5583011737408444E-3</c:v>
                  </c:pt>
                  <c:pt idx="15">
                    <c:v>1.2069745611302344E-2</c:v>
                  </c:pt>
                  <c:pt idx="16">
                    <c:v>2.64912961495779E-2</c:v>
                  </c:pt>
                  <c:pt idx="17">
                    <c:v>5.490681164699347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S$81:$S$99</c:f>
              <c:strCache>
                <c:ptCount val="19"/>
                <c:pt idx="0">
                  <c:v>WT</c:v>
                </c:pt>
                <c:pt idx="1">
                  <c:v>OETT-1</c:v>
                </c:pt>
                <c:pt idx="2">
                  <c:v>OETT-2</c:v>
                </c:pt>
                <c:pt idx="3">
                  <c:v>OETT-3</c:v>
                </c:pt>
                <c:pt idx="4">
                  <c:v>OETT-4</c:v>
                </c:pt>
                <c:pt idx="5">
                  <c:v>OETT-5</c:v>
                </c:pt>
                <c:pt idx="6">
                  <c:v>OETT-6</c:v>
                </c:pt>
                <c:pt idx="7">
                  <c:v>OETT-7</c:v>
                </c:pt>
                <c:pt idx="8">
                  <c:v>OETT-8</c:v>
                </c:pt>
                <c:pt idx="9">
                  <c:v>OETT-9</c:v>
                </c:pt>
                <c:pt idx="10">
                  <c:v>OETT-10</c:v>
                </c:pt>
                <c:pt idx="11">
                  <c:v>OETT-11</c:v>
                </c:pt>
                <c:pt idx="12">
                  <c:v>OETT-12</c:v>
                </c:pt>
                <c:pt idx="13">
                  <c:v>OETT-13</c:v>
                </c:pt>
                <c:pt idx="14">
                  <c:v>OETT-14</c:v>
                </c:pt>
                <c:pt idx="15">
                  <c:v>OETT-15</c:v>
                </c:pt>
                <c:pt idx="16">
                  <c:v>OETT-16</c:v>
                </c:pt>
                <c:pt idx="17">
                  <c:v>OETT-17</c:v>
                </c:pt>
                <c:pt idx="18">
                  <c:v>OETT-18</c:v>
                </c:pt>
              </c:strCache>
            </c:strRef>
          </c:cat>
          <c:val>
            <c:numRef>
              <c:f>Sheet5!$T$81:$T$99</c:f>
              <c:numCache>
                <c:formatCode>General</c:formatCode>
                <c:ptCount val="19"/>
                <c:pt idx="0">
                  <c:v>1.2742369509030518E-4</c:v>
                </c:pt>
                <c:pt idx="1">
                  <c:v>0.16698552972246025</c:v>
                </c:pt>
                <c:pt idx="2">
                  <c:v>0.22128047321847857</c:v>
                </c:pt>
                <c:pt idx="3">
                  <c:v>0.18188822200986596</c:v>
                </c:pt>
                <c:pt idx="4">
                  <c:v>0.10565769116161927</c:v>
                </c:pt>
                <c:pt idx="5">
                  <c:v>0.10184298742973247</c:v>
                </c:pt>
                <c:pt idx="6">
                  <c:v>0.37067391807366101</c:v>
                </c:pt>
                <c:pt idx="7">
                  <c:v>0.24933385388322371</c:v>
                </c:pt>
                <c:pt idx="8">
                  <c:v>0.18382369185604711</c:v>
                </c:pt>
                <c:pt idx="9">
                  <c:v>0.14762836648066674</c:v>
                </c:pt>
                <c:pt idx="10">
                  <c:v>0.1036096597115473</c:v>
                </c:pt>
                <c:pt idx="11">
                  <c:v>0.34051930914349454</c:v>
                </c:pt>
                <c:pt idx="12">
                  <c:v>0.14737457955466327</c:v>
                </c:pt>
                <c:pt idx="13">
                  <c:v>0.21097103814254645</c:v>
                </c:pt>
                <c:pt idx="14">
                  <c:v>2.4459209874891839E-2</c:v>
                </c:pt>
                <c:pt idx="15">
                  <c:v>0.3050289523977186</c:v>
                </c:pt>
                <c:pt idx="16">
                  <c:v>0.36931264513625267</c:v>
                </c:pt>
                <c:pt idx="17">
                  <c:v>0.43023085242526238</c:v>
                </c:pt>
                <c:pt idx="18">
                  <c:v>0.18187263209147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EE-4B34-B306-04B5801F66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6703872"/>
        <c:axId val="746713056"/>
      </c:barChart>
      <c:catAx>
        <c:axId val="746703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46713056"/>
        <c:crosses val="autoZero"/>
        <c:auto val="1"/>
        <c:lblAlgn val="ctr"/>
        <c:lblOffset val="100"/>
        <c:noMultiLvlLbl val="0"/>
      </c:catAx>
      <c:valAx>
        <c:axId val="7467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4670387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W$43:$W$56</c:f>
                <c:numCache>
                  <c:formatCode>General</c:formatCode>
                  <c:ptCount val="14"/>
                  <c:pt idx="0">
                    <c:v>9.5469054663123776E-5</c:v>
                  </c:pt>
                  <c:pt idx="1">
                    <c:v>3.9593425855690055E-2</c:v>
                  </c:pt>
                  <c:pt idx="2">
                    <c:v>1.4309457549358855E-2</c:v>
                  </c:pt>
                  <c:pt idx="3">
                    <c:v>8.1601178592669692E-6</c:v>
                  </c:pt>
                  <c:pt idx="4">
                    <c:v>2.6605342695630321E-2</c:v>
                  </c:pt>
                  <c:pt idx="5">
                    <c:v>4.6258235379598844E-3</c:v>
                  </c:pt>
                  <c:pt idx="6">
                    <c:v>8.7868516493112385E-3</c:v>
                  </c:pt>
                  <c:pt idx="7">
                    <c:v>1.1276242833951334E-2</c:v>
                  </c:pt>
                  <c:pt idx="8">
                    <c:v>2.9508772159895058E-2</c:v>
                  </c:pt>
                  <c:pt idx="9">
                    <c:v>4.5709998656627525E-2</c:v>
                  </c:pt>
                  <c:pt idx="10">
                    <c:v>1.5958548608455643E-2</c:v>
                  </c:pt>
                  <c:pt idx="11">
                    <c:v>6.1787548379780965E-3</c:v>
                  </c:pt>
                  <c:pt idx="12">
                    <c:v>9.1092429903203657E-3</c:v>
                  </c:pt>
                  <c:pt idx="13">
                    <c:v>4.42582083586614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U$43:$U$56</c:f>
              <c:strCache>
                <c:ptCount val="14"/>
                <c:pt idx="0">
                  <c:v>WT</c:v>
                </c:pt>
                <c:pt idx="1">
                  <c:v>OE_tt-1</c:v>
                </c:pt>
                <c:pt idx="2">
                  <c:v>OE_tt-3</c:v>
                </c:pt>
                <c:pt idx="3">
                  <c:v>OE_tt-4</c:v>
                </c:pt>
                <c:pt idx="4">
                  <c:v>OE_tt-5</c:v>
                </c:pt>
                <c:pt idx="5">
                  <c:v>OE_tt-7</c:v>
                </c:pt>
                <c:pt idx="6">
                  <c:v>OE_tt-8</c:v>
                </c:pt>
                <c:pt idx="7">
                  <c:v>OE_tt-9</c:v>
                </c:pt>
                <c:pt idx="8">
                  <c:v>OE_tt-10</c:v>
                </c:pt>
                <c:pt idx="9">
                  <c:v>OE_tt-11</c:v>
                </c:pt>
                <c:pt idx="10">
                  <c:v>OE_tt-12</c:v>
                </c:pt>
                <c:pt idx="11">
                  <c:v>OE_tt-15</c:v>
                </c:pt>
                <c:pt idx="12">
                  <c:v>OE_tt-16</c:v>
                </c:pt>
                <c:pt idx="13">
                  <c:v>OE_tt-17</c:v>
                </c:pt>
              </c:strCache>
            </c:strRef>
          </c:cat>
          <c:val>
            <c:numRef>
              <c:f>Sheet5!$V$43:$V$56</c:f>
              <c:numCache>
                <c:formatCode>General</c:formatCode>
                <c:ptCount val="14"/>
                <c:pt idx="0">
                  <c:v>1.3238059805715879E-4</c:v>
                </c:pt>
                <c:pt idx="1">
                  <c:v>0.31580571579997302</c:v>
                </c:pt>
                <c:pt idx="2">
                  <c:v>0.15998355265624034</c:v>
                </c:pt>
                <c:pt idx="3">
                  <c:v>2.0429627630437884E-5</c:v>
                </c:pt>
                <c:pt idx="4">
                  <c:v>0.41837217179441294</c:v>
                </c:pt>
                <c:pt idx="5">
                  <c:v>0.23289515621372642</c:v>
                </c:pt>
                <c:pt idx="6">
                  <c:v>9.4317213319296697E-2</c:v>
                </c:pt>
                <c:pt idx="7">
                  <c:v>0.12045132725119773</c:v>
                </c:pt>
                <c:pt idx="8">
                  <c:v>0.20650971268247809</c:v>
                </c:pt>
                <c:pt idx="9">
                  <c:v>0.22855048380990395</c:v>
                </c:pt>
                <c:pt idx="10">
                  <c:v>0.29878205827756155</c:v>
                </c:pt>
                <c:pt idx="11">
                  <c:v>4.7904336419770502E-2</c:v>
                </c:pt>
                <c:pt idx="12">
                  <c:v>8.2653794317420134E-2</c:v>
                </c:pt>
                <c:pt idx="13">
                  <c:v>0.14086394263057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3E-48DF-805F-3F5BEA4A33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4245736"/>
        <c:axId val="754247704"/>
      </c:barChart>
      <c:catAx>
        <c:axId val="754245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54247704"/>
        <c:crosses val="autoZero"/>
        <c:auto val="1"/>
        <c:lblAlgn val="ctr"/>
        <c:lblOffset val="100"/>
        <c:noMultiLvlLbl val="0"/>
      </c:catAx>
      <c:valAx>
        <c:axId val="754247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5424573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组合 41">
            <a:extLst>
              <a:ext uri="{FF2B5EF4-FFF2-40B4-BE49-F238E27FC236}">
                <a16:creationId xmlns:a16="http://schemas.microsoft.com/office/drawing/2014/main" id="{3DE31030-7191-40C0-96A6-40627D08D8C1}"/>
              </a:ext>
            </a:extLst>
          </p:cNvPr>
          <p:cNvGrpSpPr/>
          <p:nvPr/>
        </p:nvGrpSpPr>
        <p:grpSpPr>
          <a:xfrm>
            <a:off x="2116493" y="1591825"/>
            <a:ext cx="7482258" cy="3042069"/>
            <a:chOff x="1589443" y="626625"/>
            <a:chExt cx="7482258" cy="3042069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F07419C2-0CFE-4FA4-BBC9-2B147F103839}"/>
                </a:ext>
              </a:extLst>
            </p:cNvPr>
            <p:cNvGrpSpPr/>
            <p:nvPr/>
          </p:nvGrpSpPr>
          <p:grpSpPr>
            <a:xfrm>
              <a:off x="1769173" y="729338"/>
              <a:ext cx="3527706" cy="1029821"/>
              <a:chOff x="1769173" y="729338"/>
              <a:chExt cx="3527706" cy="1029821"/>
            </a:xfrm>
          </p:grpSpPr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B052C9F3-C6C2-4CCB-A364-358957FA5F31}"/>
                  </a:ext>
                </a:extLst>
              </p:cNvPr>
              <p:cNvPicPr/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34777" y="729338"/>
                <a:ext cx="3262102" cy="1004211"/>
              </a:xfrm>
              <a:prstGeom prst="rect">
                <a:avLst/>
              </a:prstGeom>
              <a:noFill/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333E838B-61A9-485A-B5C5-AD42CA3EC31C}"/>
                  </a:ext>
                </a:extLst>
              </p:cNvPr>
              <p:cNvSpPr txBox="1"/>
              <p:nvPr/>
            </p:nvSpPr>
            <p:spPr>
              <a:xfrm>
                <a:off x="1801735" y="1543715"/>
                <a:ext cx="4162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5D3A38E2-DCE0-4817-9AAC-C38ED2EAA7F4}"/>
                  </a:ext>
                </a:extLst>
              </p:cNvPr>
              <p:cNvSpPr txBox="1"/>
              <p:nvPr/>
            </p:nvSpPr>
            <p:spPr>
              <a:xfrm>
                <a:off x="1805809" y="1472679"/>
                <a:ext cx="3549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01F579D3-BF81-4148-9869-5D028C5B9539}"/>
                  </a:ext>
                </a:extLst>
              </p:cNvPr>
              <p:cNvSpPr txBox="1"/>
              <p:nvPr/>
            </p:nvSpPr>
            <p:spPr>
              <a:xfrm>
                <a:off x="1801735" y="1392693"/>
                <a:ext cx="4162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CE3D7CF-615A-4363-BE54-A39FFDCC0AED}"/>
                  </a:ext>
                </a:extLst>
              </p:cNvPr>
              <p:cNvSpPr txBox="1"/>
              <p:nvPr/>
            </p:nvSpPr>
            <p:spPr>
              <a:xfrm>
                <a:off x="1801735" y="1326567"/>
                <a:ext cx="4162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309C2188-827B-4B9E-B3C1-36963F21D5A8}"/>
                  </a:ext>
                </a:extLst>
              </p:cNvPr>
              <p:cNvSpPr txBox="1"/>
              <p:nvPr/>
            </p:nvSpPr>
            <p:spPr>
              <a:xfrm>
                <a:off x="1769173" y="1262124"/>
                <a:ext cx="4162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A149359C-C030-4672-A890-21A41FB39DED}"/>
                  </a:ext>
                </a:extLst>
              </p:cNvPr>
              <p:cNvSpPr txBox="1"/>
              <p:nvPr/>
            </p:nvSpPr>
            <p:spPr>
              <a:xfrm>
                <a:off x="1769174" y="1186199"/>
                <a:ext cx="4162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95E4A580-4431-4CA6-B086-9620CFA3BFA0}"/>
                </a:ext>
              </a:extLst>
            </p:cNvPr>
            <p:cNvGrpSpPr/>
            <p:nvPr/>
          </p:nvGrpSpPr>
          <p:grpSpPr>
            <a:xfrm>
              <a:off x="1983306" y="1651437"/>
              <a:ext cx="3296213" cy="2017257"/>
              <a:chOff x="531849" y="2239816"/>
              <a:chExt cx="3296213" cy="2017257"/>
            </a:xfrm>
          </p:grpSpPr>
          <p:graphicFrame>
            <p:nvGraphicFramePr>
              <p:cNvPr id="25" name="图表 24">
                <a:extLst>
                  <a:ext uri="{FF2B5EF4-FFF2-40B4-BE49-F238E27FC236}">
                    <a16:creationId xmlns:a16="http://schemas.microsoft.com/office/drawing/2014/main" id="{00000000-0008-0000-0500-00000300000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39571" y="2408529"/>
              <a:ext cx="3188491" cy="18485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DF224982-82B6-4EA6-878C-42768C971BFC}"/>
                  </a:ext>
                </a:extLst>
              </p:cNvPr>
              <p:cNvSpPr txBox="1"/>
              <p:nvPr/>
            </p:nvSpPr>
            <p:spPr>
              <a:xfrm rot="16200000">
                <a:off x="-125599" y="2897264"/>
                <a:ext cx="15303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level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4EBA10BB-3495-4C14-95AC-EFF122B2C2B3}"/>
                  </a:ext>
                </a:extLst>
              </p:cNvPr>
              <p:cNvSpPr txBox="1"/>
              <p:nvPr/>
            </p:nvSpPr>
            <p:spPr>
              <a:xfrm>
                <a:off x="952500" y="2385484"/>
                <a:ext cx="13271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MYBTT</a:t>
                </a:r>
                <a:endParaRPr lang="zh-CN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045E3EDB-402F-4EDD-9718-354957D4B079}"/>
                </a:ext>
              </a:extLst>
            </p:cNvPr>
            <p:cNvGrpSpPr/>
            <p:nvPr/>
          </p:nvGrpSpPr>
          <p:grpSpPr>
            <a:xfrm>
              <a:off x="5606683" y="1697213"/>
              <a:ext cx="3465018" cy="1953628"/>
              <a:chOff x="6353692" y="2303445"/>
              <a:chExt cx="3279081" cy="1953628"/>
            </a:xfrm>
          </p:grpSpPr>
          <p:graphicFrame>
            <p:nvGraphicFramePr>
              <p:cNvPr id="6" name="图表 5">
                <a:extLst>
                  <a:ext uri="{FF2B5EF4-FFF2-40B4-BE49-F238E27FC236}">
                    <a16:creationId xmlns:a16="http://schemas.microsoft.com/office/drawing/2014/main" id="{00000000-0008-0000-0500-00000200000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465145" y="2408529"/>
              <a:ext cx="3167628" cy="18485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9B9F5CE0-7AC6-470B-9FE7-38A1F59134E6}"/>
                  </a:ext>
                </a:extLst>
              </p:cNvPr>
              <p:cNvSpPr txBox="1"/>
              <p:nvPr/>
            </p:nvSpPr>
            <p:spPr>
              <a:xfrm rot="16200000">
                <a:off x="5696244" y="2960893"/>
                <a:ext cx="15303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level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EBEBAA6B-40F1-4CEE-AF8E-B287BA7D4580}"/>
                  </a:ext>
                </a:extLst>
              </p:cNvPr>
              <p:cNvSpPr txBox="1"/>
              <p:nvPr/>
            </p:nvSpPr>
            <p:spPr>
              <a:xfrm>
                <a:off x="6720840" y="2385484"/>
                <a:ext cx="13271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mybtt</a:t>
                </a:r>
                <a:endParaRPr lang="zh-CN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9E94F8A8-57BF-49E5-9970-0B47897ED519}"/>
                </a:ext>
              </a:extLst>
            </p:cNvPr>
            <p:cNvSpPr txBox="1"/>
            <p:nvPr/>
          </p:nvSpPr>
          <p:spPr>
            <a:xfrm>
              <a:off x="1589443" y="1759159"/>
              <a:ext cx="166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9CFCEAC4-6121-456D-81DF-AE93351D9929}"/>
                </a:ext>
              </a:extLst>
            </p:cNvPr>
            <p:cNvSpPr txBox="1"/>
            <p:nvPr/>
          </p:nvSpPr>
          <p:spPr>
            <a:xfrm>
              <a:off x="5508076" y="1759159"/>
              <a:ext cx="166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DE53670-A34D-47A6-95FF-44C3CA161810}"/>
                </a:ext>
              </a:extLst>
            </p:cNvPr>
            <p:cNvSpPr txBox="1"/>
            <p:nvPr/>
          </p:nvSpPr>
          <p:spPr>
            <a:xfrm>
              <a:off x="1589443" y="626625"/>
              <a:ext cx="166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DCC2D1AD-31FD-4B8E-B7CD-70F819BF243D}"/>
                </a:ext>
              </a:extLst>
            </p:cNvPr>
            <p:cNvSpPr txBox="1"/>
            <p:nvPr/>
          </p:nvSpPr>
          <p:spPr>
            <a:xfrm>
              <a:off x="5508076" y="626625"/>
              <a:ext cx="166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9EDDCABD-3E43-4664-ACA0-92BC04C05F90}"/>
                </a:ext>
              </a:extLst>
            </p:cNvPr>
            <p:cNvGrpSpPr/>
            <p:nvPr/>
          </p:nvGrpSpPr>
          <p:grpSpPr>
            <a:xfrm>
              <a:off x="5357342" y="729339"/>
              <a:ext cx="3714359" cy="1004210"/>
              <a:chOff x="5357342" y="729339"/>
              <a:chExt cx="3714359" cy="1004210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38FDE0E3-9E50-44F2-9DA8-A165532FAFF8}"/>
                  </a:ext>
                </a:extLst>
              </p:cNvPr>
              <p:cNvPicPr/>
              <p:nvPr/>
            </p:nvPicPr>
            <p:blipFill rotWithShape="1">
              <a:blip r:embed="rId5"/>
              <a:srcRect b="8504"/>
              <a:stretch/>
            </p:blipFill>
            <p:spPr>
              <a:xfrm>
                <a:off x="5735395" y="729339"/>
                <a:ext cx="3336306" cy="1004210"/>
              </a:xfrm>
              <a:prstGeom prst="rect">
                <a:avLst/>
              </a:prstGeom>
            </p:spPr>
          </p:pic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7FAC82CD-1571-46B9-AC39-1763B972BADC}"/>
                  </a:ext>
                </a:extLst>
              </p:cNvPr>
              <p:cNvSpPr txBox="1"/>
              <p:nvPr/>
            </p:nvSpPr>
            <p:spPr>
              <a:xfrm>
                <a:off x="5389904" y="1472679"/>
                <a:ext cx="4162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DA72F8A9-5D97-47F6-A96E-352FD9C927F8}"/>
                  </a:ext>
                </a:extLst>
              </p:cNvPr>
              <p:cNvSpPr txBox="1"/>
              <p:nvPr/>
            </p:nvSpPr>
            <p:spPr>
              <a:xfrm>
                <a:off x="5393978" y="1401643"/>
                <a:ext cx="3549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56B76A23-0FCF-4E4C-BAD2-CC94D7029FF5}"/>
                  </a:ext>
                </a:extLst>
              </p:cNvPr>
              <p:cNvSpPr txBox="1"/>
              <p:nvPr/>
            </p:nvSpPr>
            <p:spPr>
              <a:xfrm>
                <a:off x="5389904" y="1321657"/>
                <a:ext cx="4162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2F6F8B91-B71C-4E77-8295-8EC493B80C43}"/>
                  </a:ext>
                </a:extLst>
              </p:cNvPr>
              <p:cNvSpPr txBox="1"/>
              <p:nvPr/>
            </p:nvSpPr>
            <p:spPr>
              <a:xfrm>
                <a:off x="5389904" y="1255531"/>
                <a:ext cx="4162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5335CBB9-12E9-4E24-8E9A-75DA253DCE38}"/>
                  </a:ext>
                </a:extLst>
              </p:cNvPr>
              <p:cNvSpPr txBox="1"/>
              <p:nvPr/>
            </p:nvSpPr>
            <p:spPr>
              <a:xfrm>
                <a:off x="5357342" y="1191088"/>
                <a:ext cx="4162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8E412999-D92C-45B2-98CE-0F8B9E205B18}"/>
                  </a:ext>
                </a:extLst>
              </p:cNvPr>
              <p:cNvSpPr txBox="1"/>
              <p:nvPr/>
            </p:nvSpPr>
            <p:spPr>
              <a:xfrm>
                <a:off x="5357343" y="1115163"/>
                <a:ext cx="4162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23589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4</Words>
  <Application>Microsoft Office PowerPoint</Application>
  <PresentationFormat>宽屏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12</cp:revision>
  <dcterms:created xsi:type="dcterms:W3CDTF">2025-04-18T01:16:52Z</dcterms:created>
  <dcterms:modified xsi:type="dcterms:W3CDTF">2025-04-18T01:27:45Z</dcterms:modified>
</cp:coreProperties>
</file>